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100"/>
  </p:normalViewPr>
  <p:slideViewPr>
    <p:cSldViewPr snapToGrid="0" snapToObjects="1">
      <p:cViewPr varScale="1">
        <p:scale>
          <a:sx n="88" d="100"/>
          <a:sy n="88" d="100"/>
        </p:scale>
        <p:origin x="9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E07132-E7D3-1541-BE09-E5A571A769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B6E058-2EEF-E842-B497-E620921B9D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1F13B0-2633-384E-967C-A6AA71AE7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1B61B-FFB3-9344-A46F-9A56B9260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2A319A-3D2B-F146-8F23-DD63C7105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927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19186-F3AC-1F49-A71F-81A9F47E92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B21555-A79B-7E44-AC85-2FDFFA7F23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F33054-909E-6945-B5CE-DC0A2121B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F12A3-DAFD-5641-87AE-DF5F96586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5B19B2-D357-6B44-8BE8-7372ABBE3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441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17CA58-4550-8E49-A8B6-D0726686E3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DF3940-FE80-314D-AF9C-6B9FB8E05C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8F9B0C-0DBC-5349-9046-3C7008D1E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C02AA-EA12-DE40-9B1B-7BDE57C4A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FE93EC-6807-B143-A593-CFD49F20D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568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36ECA-AC2C-7043-A48C-CDDD2E603B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B28835-D281-764E-9FB5-CD8AE62FD2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F594B-A336-854C-8843-C44A0AD28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85EDDB-2D0B-8F43-ABB5-3948D5522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5080B5-49E4-A049-BA7C-3ED319834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364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C35EBD-2FF7-C943-9BD4-DF8FADD1D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0EEF52-78FC-4A46-B618-74164F3BBA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2BEB0E-850B-8E49-AA79-3E1BEE84F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291E7C-735A-7D4D-AD07-5C082F4E7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C38311-2551-1642-8797-DA3F810EB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784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D8423-5A72-9548-8BED-99537C58D4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EF46E4-A1DE-F548-8552-49C47B1744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2D3853-47CF-7E49-ACB4-C637818BDA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1A67FA-4CD2-854F-86A8-4A91F0EDC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79C7D1-C3E8-5443-8831-05B8317EA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FE295B-B3E5-C44E-AAB6-DB564D93A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986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A6BE4-74B1-8E4F-A109-F9A190204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E44FF2-375B-094E-B51B-8B8BCA55AD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BF6895-3BC7-E043-8EC0-F1CDE2C503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D996E6-4253-3F4A-A9A7-556D5AB985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36AEA9-35E9-5D44-8CC3-8D93EF1453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87A1AD-8086-A74D-A3BA-ED5E1D41A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51289B-237C-5241-88B6-E0B1C32DD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0AE9DA-83FE-F042-A3CC-A25746510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374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8831E-CB40-334C-89AB-F9CEA3C025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E0F1D2-BC1C-F34D-A627-7536ED9CD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CCABFE-C336-8E48-AE19-469903B58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EF1156-22D9-FF45-8F9A-9D553E615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851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878AB1-E8A4-9143-8403-70DC3F9A7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02C000-6C38-354B-9EB0-C321D1179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82B6F2-0A63-784E-BAAC-7B28D7AF4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077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0EC5E-8912-5A4F-A28E-CEF65F86A0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BE13B3-FE87-5B41-A9FB-7C373ECDCD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CFE840-3290-7B4C-8E84-76B85F935D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64778C-3F08-F842-A57F-AB325BBE3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BD9B15-D82A-EE4F-9F98-429608B5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2C5D8E-1748-7547-B987-8727CE561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875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67B75-9807-4943-BFCD-9DD271BDD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694FF1-2D02-3F4A-ABEB-78E5DFDA14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03C56B-CB1E-BC46-8703-67CB31E7BB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2E9CA0-B6D7-E54C-A141-C67F1650A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947385-046A-E24E-9298-4F8975FEE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529807-4C99-A24A-8E4D-736C56810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845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C7EFD9-CFA5-8D43-9760-1D9A2492D6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209AB0-CCD8-474C-BE32-9CBD0CA8BC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8BE4EE-8AAC-EF41-A2F5-8C7E70FB59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DB1EB-7CF8-DB42-A171-09A59E1576E0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8CB0EB-631E-0341-A120-31712FEBF2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DFED7-9924-C343-B671-B7C1613521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EC6DE-5445-044D-9361-F07365E630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875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ti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6D626B1-C8EF-734F-A72D-18D1CB7F949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0000" contrast="11000"/>
                    </a14:imgEffect>
                  </a14:imgLayer>
                </a14:imgProps>
              </a:ext>
            </a:extLst>
          </a:blip>
          <a:srcRect l="-6026" t="-2293" r="-4071" b="-5809"/>
          <a:stretch/>
        </p:blipFill>
        <p:spPr>
          <a:xfrm>
            <a:off x="7634801" y="529673"/>
            <a:ext cx="3495553" cy="2104296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1558392-0AE8-D842-9159-37A83A5A1AB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9000" contrast="10000"/>
                    </a14:imgEffect>
                  </a14:imgLayer>
                </a14:imgProps>
              </a:ext>
            </a:extLst>
          </a:blip>
          <a:srcRect l="-3238" t="-8301" r="-3115" b="-23739"/>
          <a:stretch/>
        </p:blipFill>
        <p:spPr>
          <a:xfrm>
            <a:off x="127322" y="4422604"/>
            <a:ext cx="3795494" cy="1324761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D209701-3B65-D149-A0D2-1DF4DD7DF5F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3680" t="-15762" r="-1781" b="-15613"/>
          <a:stretch/>
        </p:blipFill>
        <p:spPr>
          <a:xfrm>
            <a:off x="305013" y="1153263"/>
            <a:ext cx="3799866" cy="1067813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17366D8-3F78-B940-8CAD-DBF77E5EDA5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6000" contrast="16000"/>
                    </a14:imgEffect>
                  </a14:imgLayer>
                </a14:imgProps>
              </a:ext>
            </a:extLst>
          </a:blip>
          <a:srcRect l="-4389" t="-16279" r="-1141" b="-18207"/>
          <a:stretch/>
        </p:blipFill>
        <p:spPr>
          <a:xfrm>
            <a:off x="1145894" y="177181"/>
            <a:ext cx="3055716" cy="1216362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7F9ABEF-B03F-C144-BA09-D653C4BC4C7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2000" contrast="15000"/>
                    </a14:imgEffect>
                  </a14:imgLayer>
                </a14:imgProps>
              </a:ext>
            </a:extLst>
          </a:blip>
          <a:srcRect l="-9647" t="-16853" r="-3546" b="-20394"/>
          <a:stretch/>
        </p:blipFill>
        <p:spPr>
          <a:xfrm>
            <a:off x="487077" y="5557486"/>
            <a:ext cx="3435739" cy="888956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2B9E241-D0EC-524B-A028-4C41FB51690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7000"/>
                    </a14:imgEffect>
                  </a14:imgLayer>
                </a14:imgProps>
              </a:ext>
            </a:extLst>
          </a:blip>
          <a:srcRect l="-1721" t="-10812" r="-3847" b="-22847"/>
          <a:stretch/>
        </p:blipFill>
        <p:spPr>
          <a:xfrm>
            <a:off x="7658329" y="2740253"/>
            <a:ext cx="3217763" cy="933612"/>
          </a:xfrm>
          <a:prstGeom prst="rect">
            <a:avLst/>
          </a:prstGeom>
          <a:ln>
            <a:noFill/>
          </a:ln>
        </p:spPr>
      </p:pic>
      <p:sp>
        <p:nvSpPr>
          <p:cNvPr id="10" name="ZoneTexte 18">
            <a:extLst>
              <a:ext uri="{FF2B5EF4-FFF2-40B4-BE49-F238E27FC236}">
                <a16:creationId xmlns:a16="http://schemas.microsoft.com/office/drawing/2014/main" id="{FE188156-FCD4-DF47-A9D9-67E50A5C783A}"/>
              </a:ext>
            </a:extLst>
          </p:cNvPr>
          <p:cNvSpPr txBox="1"/>
          <p:nvPr/>
        </p:nvSpPr>
        <p:spPr>
          <a:xfrm>
            <a:off x="3922816" y="4808134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p4Ebp1 </a:t>
            </a:r>
          </a:p>
        </p:txBody>
      </p:sp>
      <p:sp>
        <p:nvSpPr>
          <p:cNvPr id="11" name="ZoneTexte 18">
            <a:extLst>
              <a:ext uri="{FF2B5EF4-FFF2-40B4-BE49-F238E27FC236}">
                <a16:creationId xmlns:a16="http://schemas.microsoft.com/office/drawing/2014/main" id="{95A6CA96-49C8-DB44-8309-2D4E9079F615}"/>
              </a:ext>
            </a:extLst>
          </p:cNvPr>
          <p:cNvSpPr txBox="1"/>
          <p:nvPr/>
        </p:nvSpPr>
        <p:spPr>
          <a:xfrm>
            <a:off x="3785721" y="5888822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4Ebp1</a:t>
            </a:r>
          </a:p>
        </p:txBody>
      </p:sp>
      <p:sp>
        <p:nvSpPr>
          <p:cNvPr id="12" name="ZoneTexte 18">
            <a:extLst>
              <a:ext uri="{FF2B5EF4-FFF2-40B4-BE49-F238E27FC236}">
                <a16:creationId xmlns:a16="http://schemas.microsoft.com/office/drawing/2014/main" id="{2B16DA3F-4E14-CB4B-88EF-44C1FA7EB805}"/>
              </a:ext>
            </a:extLst>
          </p:cNvPr>
          <p:cNvSpPr txBox="1"/>
          <p:nvPr/>
        </p:nvSpPr>
        <p:spPr>
          <a:xfrm>
            <a:off x="4199754" y="1616998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Ampk1</a:t>
            </a:r>
          </a:p>
        </p:txBody>
      </p:sp>
      <p:sp>
        <p:nvSpPr>
          <p:cNvPr id="13" name="ZoneTexte 18">
            <a:extLst>
              <a:ext uri="{FF2B5EF4-FFF2-40B4-BE49-F238E27FC236}">
                <a16:creationId xmlns:a16="http://schemas.microsoft.com/office/drawing/2014/main" id="{D22A4EF7-25C6-B64B-8F3E-B26E755878B6}"/>
              </a:ext>
            </a:extLst>
          </p:cNvPr>
          <p:cNvSpPr txBox="1"/>
          <p:nvPr/>
        </p:nvSpPr>
        <p:spPr>
          <a:xfrm>
            <a:off x="4412727" y="529673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pAmpk1</a:t>
            </a:r>
          </a:p>
        </p:txBody>
      </p:sp>
      <p:sp>
        <p:nvSpPr>
          <p:cNvPr id="14" name="ZoneTexte 18">
            <a:extLst>
              <a:ext uri="{FF2B5EF4-FFF2-40B4-BE49-F238E27FC236}">
                <a16:creationId xmlns:a16="http://schemas.microsoft.com/office/drawing/2014/main" id="{9B67215C-C2A4-8341-8DBC-9382E65C46A7}"/>
              </a:ext>
            </a:extLst>
          </p:cNvPr>
          <p:cNvSpPr txBox="1"/>
          <p:nvPr/>
        </p:nvSpPr>
        <p:spPr>
          <a:xfrm>
            <a:off x="11130354" y="101476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Stard7</a:t>
            </a:r>
          </a:p>
        </p:txBody>
      </p:sp>
      <p:sp>
        <p:nvSpPr>
          <p:cNvPr id="15" name="ZoneTexte 18">
            <a:extLst>
              <a:ext uri="{FF2B5EF4-FFF2-40B4-BE49-F238E27FC236}">
                <a16:creationId xmlns:a16="http://schemas.microsoft.com/office/drawing/2014/main" id="{96DF1936-7CD8-9042-916D-CA48A9EA561B}"/>
              </a:ext>
            </a:extLst>
          </p:cNvPr>
          <p:cNvSpPr txBox="1"/>
          <p:nvPr/>
        </p:nvSpPr>
        <p:spPr>
          <a:xfrm>
            <a:off x="10876823" y="2924187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Hsp90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D0CB771-F557-FE40-B6D9-E507D4BA980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rcRect l="-11032" t="-20400" r="-7194" b="-5985"/>
          <a:stretch/>
        </p:blipFill>
        <p:spPr>
          <a:xfrm>
            <a:off x="822884" y="2856092"/>
            <a:ext cx="3183038" cy="690188"/>
          </a:xfrm>
          <a:prstGeom prst="rect">
            <a:avLst/>
          </a:prstGeom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23638A8-D368-F04A-8CF5-2999C0022B0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rcRect l="-4425" t="-7105" r="-6357" b="-18960"/>
          <a:stretch/>
        </p:blipFill>
        <p:spPr>
          <a:xfrm>
            <a:off x="779591" y="3711663"/>
            <a:ext cx="3348454" cy="816514"/>
          </a:xfrm>
          <a:prstGeom prst="rect">
            <a:avLst/>
          </a:prstGeom>
          <a:ln>
            <a:noFill/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F9F1C6C-4F16-3540-9B78-CEF341A8D8D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8000" contrast="25000"/>
                    </a14:imgEffect>
                  </a14:imgLayer>
                </a14:imgProps>
              </a:ext>
            </a:extLst>
          </a:blip>
          <a:srcRect l="-3647" t="-23918" r="-3469" b="-20224"/>
          <a:stretch/>
        </p:blipFill>
        <p:spPr>
          <a:xfrm>
            <a:off x="741147" y="2100910"/>
            <a:ext cx="3346512" cy="933612"/>
          </a:xfrm>
          <a:prstGeom prst="rect">
            <a:avLst/>
          </a:prstGeom>
          <a:ln>
            <a:noFill/>
          </a:ln>
        </p:spPr>
      </p:pic>
      <p:sp>
        <p:nvSpPr>
          <p:cNvPr id="19" name="ZoneTexte 18">
            <a:extLst>
              <a:ext uri="{FF2B5EF4-FFF2-40B4-BE49-F238E27FC236}">
                <a16:creationId xmlns:a16="http://schemas.microsoft.com/office/drawing/2014/main" id="{C66D6FFC-97FE-9948-9BBA-5F24DB40ABD6}"/>
              </a:ext>
            </a:extLst>
          </p:cNvPr>
          <p:cNvSpPr txBox="1"/>
          <p:nvPr/>
        </p:nvSpPr>
        <p:spPr>
          <a:xfrm>
            <a:off x="3895776" y="3107061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latin typeface="Times New Roman"/>
                <a:cs typeface="Times New Roman"/>
              </a:rPr>
              <a:t>pLkb</a:t>
            </a:r>
            <a:endParaRPr lang="fr-FR" sz="1400" b="1" dirty="0">
              <a:latin typeface="Times New Roman"/>
              <a:cs typeface="Times New Roman"/>
            </a:endParaRPr>
          </a:p>
        </p:txBody>
      </p:sp>
      <p:sp>
        <p:nvSpPr>
          <p:cNvPr id="20" name="ZoneTexte 18">
            <a:extLst>
              <a:ext uri="{FF2B5EF4-FFF2-40B4-BE49-F238E27FC236}">
                <a16:creationId xmlns:a16="http://schemas.microsoft.com/office/drawing/2014/main" id="{B68965EB-A665-624B-9AC7-C6B4AE266391}"/>
              </a:ext>
            </a:extLst>
          </p:cNvPr>
          <p:cNvSpPr txBox="1"/>
          <p:nvPr/>
        </p:nvSpPr>
        <p:spPr>
          <a:xfrm>
            <a:off x="3873007" y="3946422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latin typeface="Times New Roman"/>
                <a:cs typeface="Times New Roman"/>
              </a:rPr>
              <a:t>Lkb</a:t>
            </a:r>
            <a:endParaRPr lang="fr-FR" sz="1400" b="1" dirty="0">
              <a:latin typeface="Times New Roman"/>
              <a:cs typeface="Times New Roman"/>
            </a:endParaRPr>
          </a:p>
        </p:txBody>
      </p:sp>
      <p:sp>
        <p:nvSpPr>
          <p:cNvPr id="21" name="ZoneTexte 18">
            <a:extLst>
              <a:ext uri="{FF2B5EF4-FFF2-40B4-BE49-F238E27FC236}">
                <a16:creationId xmlns:a16="http://schemas.microsoft.com/office/drawing/2014/main" id="{1F182004-D36E-2243-A6FF-607C57441C29}"/>
              </a:ext>
            </a:extLst>
          </p:cNvPr>
          <p:cNvSpPr txBox="1"/>
          <p:nvPr/>
        </p:nvSpPr>
        <p:spPr>
          <a:xfrm>
            <a:off x="3954194" y="2468107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Gpx4</a:t>
            </a:r>
          </a:p>
        </p:txBody>
      </p:sp>
      <p:sp>
        <p:nvSpPr>
          <p:cNvPr id="22" name="ZoneTexte 5">
            <a:extLst>
              <a:ext uri="{FF2B5EF4-FFF2-40B4-BE49-F238E27FC236}">
                <a16:creationId xmlns:a16="http://schemas.microsoft.com/office/drawing/2014/main" id="{70D462AB-C1B9-B849-80B8-8AFB66042E7F}"/>
              </a:ext>
            </a:extLst>
          </p:cNvPr>
          <p:cNvSpPr txBox="1"/>
          <p:nvPr/>
        </p:nvSpPr>
        <p:spPr>
          <a:xfrm>
            <a:off x="5087545" y="100210"/>
            <a:ext cx="1148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fr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BE1025A-8A1B-7B47-A22E-807F1B044F27}"/>
              </a:ext>
            </a:extLst>
          </p:cNvPr>
          <p:cNvSpPr/>
          <p:nvPr/>
        </p:nvSpPr>
        <p:spPr>
          <a:xfrm>
            <a:off x="1485784" y="579716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8E94082-32A4-3846-AAB6-D6824F034067}"/>
              </a:ext>
            </a:extLst>
          </p:cNvPr>
          <p:cNvSpPr/>
          <p:nvPr/>
        </p:nvSpPr>
        <p:spPr>
          <a:xfrm>
            <a:off x="1244128" y="1580488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C513B7D-A446-5044-AB79-6B31AE2A12C8}"/>
              </a:ext>
            </a:extLst>
          </p:cNvPr>
          <p:cNvSpPr/>
          <p:nvPr/>
        </p:nvSpPr>
        <p:spPr>
          <a:xfrm>
            <a:off x="1284123" y="2394039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3DA61566-FCB2-8641-83E0-FF0C75D9F2B4}"/>
              </a:ext>
            </a:extLst>
          </p:cNvPr>
          <p:cNvSpPr/>
          <p:nvPr/>
        </p:nvSpPr>
        <p:spPr>
          <a:xfrm>
            <a:off x="1284123" y="3061584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137EA9A-75E4-BD49-B0AC-D6AEA70AC61B}"/>
              </a:ext>
            </a:extLst>
          </p:cNvPr>
          <p:cNvSpPr/>
          <p:nvPr/>
        </p:nvSpPr>
        <p:spPr>
          <a:xfrm>
            <a:off x="1222794" y="3955123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1A6D454-28ED-A34A-911E-F1EAFD2B0235}"/>
              </a:ext>
            </a:extLst>
          </p:cNvPr>
          <p:cNvSpPr/>
          <p:nvPr/>
        </p:nvSpPr>
        <p:spPr>
          <a:xfrm>
            <a:off x="807489" y="4809133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D9DB955-8234-3E4C-AFD8-DA875588D0F0}"/>
              </a:ext>
            </a:extLst>
          </p:cNvPr>
          <p:cNvSpPr/>
          <p:nvPr/>
        </p:nvSpPr>
        <p:spPr>
          <a:xfrm>
            <a:off x="968355" y="5773441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1345D55-24E0-5443-B50D-E8B9F1119C17}"/>
              </a:ext>
            </a:extLst>
          </p:cNvPr>
          <p:cNvSpPr/>
          <p:nvPr/>
        </p:nvSpPr>
        <p:spPr>
          <a:xfrm>
            <a:off x="8217640" y="1047329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2823245-5EEC-AC49-B3FA-F296FE7B954E}"/>
              </a:ext>
            </a:extLst>
          </p:cNvPr>
          <p:cNvSpPr/>
          <p:nvPr/>
        </p:nvSpPr>
        <p:spPr>
          <a:xfrm>
            <a:off x="7980574" y="3028079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BDCCFC9-A18D-5642-A2D5-52CF2310198D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5709831" y="1183578"/>
            <a:ext cx="736600" cy="28575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5C33987A-9A09-F344-9673-CCCC629FC265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711618" y="3656234"/>
            <a:ext cx="736600" cy="2857500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2CB3D725-0506-4B4A-9920-3419C0325658}"/>
              </a:ext>
            </a:extLst>
          </p:cNvPr>
          <p:cNvSpPr/>
          <p:nvPr/>
        </p:nvSpPr>
        <p:spPr>
          <a:xfrm>
            <a:off x="4881508" y="4805996"/>
            <a:ext cx="160454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3AFCFF1-3EE4-504F-966B-728C375750A9}"/>
              </a:ext>
            </a:extLst>
          </p:cNvPr>
          <p:cNvSpPr/>
          <p:nvPr/>
        </p:nvSpPr>
        <p:spPr>
          <a:xfrm>
            <a:off x="4870130" y="2394038"/>
            <a:ext cx="1684268" cy="4620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CF1F288-763C-054D-9553-F0943542C48F}"/>
              </a:ext>
            </a:extLst>
          </p:cNvPr>
          <p:cNvSpPr txBox="1"/>
          <p:nvPr/>
        </p:nvSpPr>
        <p:spPr>
          <a:xfrm>
            <a:off x="5013027" y="3017997"/>
            <a:ext cx="25635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second membrane, not shown in Figure 5F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DD415D0-E539-A44A-AA7A-88F7210EEB9F}"/>
              </a:ext>
            </a:extLst>
          </p:cNvPr>
          <p:cNvSpPr txBox="1"/>
          <p:nvPr/>
        </p:nvSpPr>
        <p:spPr>
          <a:xfrm>
            <a:off x="4790394" y="5557486"/>
            <a:ext cx="36932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third membrane, not shown in Figure 5F.)</a:t>
            </a:r>
          </a:p>
        </p:txBody>
      </p:sp>
    </p:spTree>
    <p:extLst>
      <p:ext uri="{BB962C8B-B14F-4D97-AF65-F5344CB8AC3E}">
        <p14:creationId xmlns:p14="http://schemas.microsoft.com/office/powerpoint/2010/main" val="1384559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1</cp:revision>
  <dcterms:created xsi:type="dcterms:W3CDTF">2025-12-05T15:02:49Z</dcterms:created>
  <dcterms:modified xsi:type="dcterms:W3CDTF">2025-12-05T15:03:08Z</dcterms:modified>
  <cp:category/>
</cp:coreProperties>
</file>